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75C6D7-12B0-41A5-91B7-4EC02E7193C6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PTEN-null status of XTC.UC1 cells. (A) Electropherogram showing the hemizygous c.210delT within exon 4 of the </a:t>
            </a:r>
            <a:r>
              <a:rPr b="0" i="1" lang="it-IT" sz="1200" spc="-1" strike="noStrike">
                <a:solidFill>
                  <a:srgbClr val="000000"/>
                </a:solidFill>
                <a:latin typeface="Arial"/>
              </a:rPr>
              <a:t>PTEN</a:t>
            </a: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 gene in XTC.UC1 cells compared to a wild-type control (lower panel). The wild-type c.210delT is underlined. (B) Western blot for PTEN confirming lack of the full-length protein in XTC.UC1 cells compared to a control. Beta-actin was used as a loading contro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B913B-2206-47D3-ABB5-31F50399CB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2E3D4-6B0A-4CE8-8E44-4C39C57D3A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F8AC3-A9CC-40D2-B660-64171D98F9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78E80-27A2-41BC-B76F-50BEF4A60A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14DBA-8F2E-4E7B-AE86-91E393F606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337F9-FC8C-46FF-A8F2-87BBDDFCD2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B15D6-E139-42E5-8B3F-EEF2D87C32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9A55E-2769-457B-8C51-D3FFEF0604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CB6C0-5D4E-43DA-8BD8-D41514B8A0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9F2D68-BACC-450A-AFB5-9E97B8211C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4223C-45BA-4C7E-8B3A-3910044635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3B50C-B6DA-4A3C-8293-321BB84C30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A3826A-8003-4666-A67B-E341D9E0A605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830880" y="603360"/>
            <a:ext cx="3392280" cy="2683800"/>
            <a:chOff x="830880" y="603360"/>
            <a:chExt cx="3392280" cy="2683800"/>
          </a:xfrm>
        </p:grpSpPr>
        <p:pic>
          <p:nvPicPr>
            <p:cNvPr id="49" name="" descr=""/>
            <p:cNvPicPr/>
            <p:nvPr/>
          </p:nvPicPr>
          <p:blipFill>
            <a:blip r:embed="rId1"/>
            <a:srcRect l="32289" t="0" r="0" b="0"/>
            <a:stretch/>
          </p:blipFill>
          <p:spPr>
            <a:xfrm>
              <a:off x="842760" y="819360"/>
              <a:ext cx="2263680" cy="1038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2"/>
            <a:srcRect l="31251" t="34687" r="0" b="0"/>
            <a:stretch/>
          </p:blipFill>
          <p:spPr>
            <a:xfrm>
              <a:off x="842760" y="2187720"/>
              <a:ext cx="2455920" cy="795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830880" y="603360"/>
              <a:ext cx="2322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T  T   T  T  A  G  T   G  T  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840960" y="1883160"/>
              <a:ext cx="2484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T  T   T  T  A  G  T  </a:t>
              </a:r>
              <a:r>
                <a:rPr b="1" lang="en-US" sz="14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T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 G  T  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754280" y="2980080"/>
              <a:ext cx="65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PTE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277440" y="1251000"/>
              <a:ext cx="94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XTC.UC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274920" y="2459160"/>
              <a:ext cx="776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"/>
          <p:cNvSpPr/>
          <p:nvPr/>
        </p:nvSpPr>
        <p:spPr>
          <a:xfrm rot="18204600">
            <a:off x="4933440" y="757440"/>
            <a:ext cx="94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XTC.UC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8204600">
            <a:off x="5629320" y="827280"/>
            <a:ext cx="776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6357960" y="2041560"/>
            <a:ext cx="71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Symbol"/>
                <a:ea typeface="Symbol"/>
              </a:rPr>
              <a:t></a:t>
            </a:r>
            <a:r>
              <a:rPr b="1" lang="it-IT" sz="1400" spc="-1" strike="noStrike">
                <a:solidFill>
                  <a:srgbClr val="000000"/>
                </a:solidFill>
                <a:latin typeface="Times New Roman"/>
              </a:rPr>
              <a:t>AC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337440" y="143496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TE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2" descr=""/>
          <p:cNvPicPr/>
          <p:nvPr/>
        </p:nvPicPr>
        <p:blipFill>
          <a:blip r:embed="rId3"/>
          <a:srcRect l="72658" t="0" r="0" b="0"/>
          <a:stretch/>
        </p:blipFill>
        <p:spPr>
          <a:xfrm>
            <a:off x="4822920" y="1320840"/>
            <a:ext cx="1441440" cy="57132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181080" y="189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453200" y="1890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3" name=""/>
          <p:cNvGraphicFramePr/>
          <p:nvPr/>
        </p:nvGraphicFramePr>
        <p:xfrm>
          <a:off x="4822920" y="1969920"/>
          <a:ext cx="1439640" cy="45108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64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4822920" y="1969920"/>
                    <a:ext cx="1439640" cy="451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5" name=""/>
          <p:cNvSpPr/>
          <p:nvPr/>
        </p:nvSpPr>
        <p:spPr>
          <a:xfrm>
            <a:off x="1042920" y="4005360"/>
            <a:ext cx="720108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PTEN-null status of XTC.UC1 cells. (A) Electropherogram showing the hemizygous c.210delT within exon 4 of the </a:t>
            </a:r>
            <a:r>
              <a:rPr b="0" i="1" lang="it-IT" sz="1800" spc="-1" strike="noStrike">
                <a:solidFill>
                  <a:srgbClr val="000000"/>
                </a:solidFill>
                <a:latin typeface="Arial"/>
              </a:rPr>
              <a:t>PTEN</a:t>
            </a: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 gene in XTC.UC1 cells compared to a wild-type control (lower panel). The wild-type c.210delT is underlined. (B) Western blot for PTEN confirming lack of the full-length protein in XTC.UC1 cells compared to a control. Beta-actin was used as a loading contro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16T12:00:03Z</dcterms:created>
  <dc:creator>labgenmed</dc:creator>
  <dc:description/>
  <dc:language>en-US</dc:language>
  <cp:lastModifiedBy>daniela.turchetti</cp:lastModifiedBy>
  <dcterms:modified xsi:type="dcterms:W3CDTF">2013-12-16T16:51:49Z</dcterms:modified>
  <cp:revision>3</cp:revision>
  <dc:subject/>
  <dc:title>Diapositiva 1</dc:title>
</cp:coreProperties>
</file>